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20"/>
    <p:restoredTop sz="94660"/>
  </p:normalViewPr>
  <p:slideViewPr>
    <p:cSldViewPr snapToGrid="0">
      <p:cViewPr varScale="1">
        <p:scale>
          <a:sx n="88" d="100"/>
          <a:sy n="88" d="100"/>
        </p:scale>
        <p:origin x="-588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10397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23832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22830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00492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15844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9591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55595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73695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22734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4682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88781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5161B-B8B7-4BCB-BA64-0AF5CCD7FEED}" type="datetimeFigureOut">
              <a:rPr lang="en-US" smtClean="0"/>
              <a:pPr/>
              <a:t>4/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DADB52-9E20-4357-ADFE-41D3F8340E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56844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511055" y="900911"/>
            <a:ext cx="5830941" cy="2957802"/>
            <a:chOff x="724606" y="1161649"/>
            <a:chExt cx="5830941" cy="2501811"/>
          </a:xfrm>
        </p:grpSpPr>
        <p:grpSp>
          <p:nvGrpSpPr>
            <p:cNvPr id="3" name="Group 7"/>
            <p:cNvGrpSpPr/>
            <p:nvPr/>
          </p:nvGrpSpPr>
          <p:grpSpPr>
            <a:xfrm>
              <a:off x="990600" y="1173695"/>
              <a:ext cx="931652" cy="2483905"/>
              <a:chOff x="2057400" y="1173695"/>
              <a:chExt cx="931652" cy="2483905"/>
            </a:xfrm>
          </p:grpSpPr>
          <p:pic>
            <p:nvPicPr>
              <p:cNvPr id="23" name="Picture 2" descr="G:\COLONY PCR pETERF.tif"/>
              <p:cNvPicPr>
                <a:picLocks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="" xmlns:a14="http://schemas.microsoft.com/office/drawing/2010/main">
                      <a14:imgLayer r:embed="">
                        <a14:imgEffect>
                          <a14:saturation sat="40000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r="80268"/>
              <a:stretch>
                <a:fillRect/>
              </a:stretch>
            </p:blipFill>
            <p:spPr bwMode="auto">
              <a:xfrm>
                <a:off x="2057400" y="1371600"/>
                <a:ext cx="914400" cy="2286000"/>
              </a:xfrm>
              <a:prstGeom prst="rect">
                <a:avLst/>
              </a:prstGeom>
              <a:noFill/>
            </p:spPr>
          </p:pic>
          <p:sp>
            <p:nvSpPr>
              <p:cNvPr id="24" name="TextBox 4"/>
              <p:cNvSpPr txBox="1"/>
              <p:nvPr/>
            </p:nvSpPr>
            <p:spPr>
              <a:xfrm>
                <a:off x="2074652" y="1173695"/>
                <a:ext cx="9144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   M        1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" name="Group 12"/>
            <p:cNvGrpSpPr/>
            <p:nvPr/>
          </p:nvGrpSpPr>
          <p:grpSpPr>
            <a:xfrm>
              <a:off x="2971800" y="1173695"/>
              <a:ext cx="931652" cy="2483905"/>
              <a:chOff x="3733800" y="1173695"/>
              <a:chExt cx="931652" cy="2483905"/>
            </a:xfrm>
          </p:grpSpPr>
          <p:pic>
            <p:nvPicPr>
              <p:cNvPr id="21" name="Picture 3" descr="G:\BpROMOTER RES DOG WITH BGL2 AND DOUBLE DIG VID PST AND BAM.jpg"/>
              <p:cNvPicPr>
                <a:picLocks noChangeArrowheads="1"/>
              </p:cNvPicPr>
              <p:nvPr/>
            </p:nvPicPr>
            <p:blipFill>
              <a:blip r:embed="rId3" cstate="print">
                <a:lum contrast="20000"/>
              </a:blip>
              <a:srcRect r="87500"/>
              <a:stretch>
                <a:fillRect/>
              </a:stretch>
            </p:blipFill>
            <p:spPr bwMode="auto">
              <a:xfrm>
                <a:off x="3733800" y="1371600"/>
                <a:ext cx="914400" cy="2286000"/>
              </a:xfrm>
              <a:prstGeom prst="rect">
                <a:avLst/>
              </a:prstGeom>
              <a:noFill/>
            </p:spPr>
          </p:pic>
          <p:sp>
            <p:nvSpPr>
              <p:cNvPr id="22" name="TextBox 5"/>
              <p:cNvSpPr txBox="1"/>
              <p:nvPr/>
            </p:nvSpPr>
            <p:spPr>
              <a:xfrm>
                <a:off x="3751052" y="1173695"/>
                <a:ext cx="9144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    M      1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" name="Group 17"/>
            <p:cNvGrpSpPr/>
            <p:nvPr/>
          </p:nvGrpSpPr>
          <p:grpSpPr>
            <a:xfrm>
              <a:off x="4724400" y="1180991"/>
              <a:ext cx="931652" cy="2482469"/>
              <a:chOff x="5410200" y="1180991"/>
              <a:chExt cx="931652" cy="2482469"/>
            </a:xfrm>
          </p:grpSpPr>
          <p:pic>
            <p:nvPicPr>
              <p:cNvPr id="19" name="Picture 4" descr="G:\BpROMOTER RES DOG WITH full BGL2 AND DOUBLE DIG VID .PST AND BAM.tif"/>
              <p:cNvPicPr>
                <a:picLocks noChangeArrowheads="1"/>
              </p:cNvPicPr>
              <p:nvPr/>
            </p:nvPicPr>
            <p:blipFill>
              <a:blip r:embed="rId4" cstate="print">
                <a:lum bright="10000" contrast="40000"/>
              </a:blip>
              <a:srcRect r="68236"/>
              <a:stretch>
                <a:fillRect/>
              </a:stretch>
            </p:blipFill>
            <p:spPr bwMode="auto">
              <a:xfrm>
                <a:off x="5410200" y="1377460"/>
                <a:ext cx="914400" cy="2286000"/>
              </a:xfrm>
              <a:prstGeom prst="rect">
                <a:avLst/>
              </a:prstGeom>
              <a:noFill/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5427452" y="1180991"/>
                <a:ext cx="9144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  M         1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6" name="Straight Arrow Connector 5"/>
            <p:cNvCxnSpPr/>
            <p:nvPr/>
          </p:nvCxnSpPr>
          <p:spPr>
            <a:xfrm rot="10800000">
              <a:off x="1905000" y="2390336"/>
              <a:ext cx="381000" cy="158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1905000" y="2438400"/>
              <a:ext cx="1066800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1 kb </a:t>
              </a:r>
              <a:r>
                <a:rPr lang="en-US" sz="1100" i="1" dirty="0" smtClean="0">
                  <a:latin typeface="Arial" pitchFamily="34" charset="0"/>
                  <a:cs typeface="Arial" pitchFamily="34" charset="0"/>
                </a:rPr>
                <a:t>OsXPB2</a:t>
              </a:r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 Promoter </a:t>
              </a:r>
            </a:p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amplification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" name="Straight Arrow Connector 7"/>
            <p:cNvCxnSpPr/>
            <p:nvPr/>
          </p:nvCxnSpPr>
          <p:spPr>
            <a:xfrm rot="10800000">
              <a:off x="3886201" y="2444260"/>
              <a:ext cx="381000" cy="158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rot="10800000">
              <a:off x="3883853" y="2878020"/>
              <a:ext cx="381000" cy="158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3962400" y="2007513"/>
              <a:ext cx="838200" cy="43088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Vector backbone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962400" y="2923736"/>
              <a:ext cx="838200" cy="60016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1 kb </a:t>
              </a:r>
              <a:r>
                <a:rPr lang="en-US" sz="1100" i="1" dirty="0" smtClean="0">
                  <a:latin typeface="Arial" pitchFamily="34" charset="0"/>
                  <a:cs typeface="Arial" pitchFamily="34" charset="0"/>
                </a:rPr>
                <a:t>OsXPB2</a:t>
              </a:r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 Promoter </a:t>
              </a: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rot="10800000">
              <a:off x="5641148" y="1981201"/>
              <a:ext cx="381000" cy="158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 rot="10800000">
              <a:off x="5638800" y="2756105"/>
              <a:ext cx="381000" cy="158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5717347" y="2801821"/>
              <a:ext cx="838200" cy="60016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1 kb </a:t>
              </a:r>
              <a:r>
                <a:rPr lang="en-US" sz="1100" i="1" dirty="0" smtClean="0">
                  <a:latin typeface="Arial" pitchFamily="34" charset="0"/>
                  <a:cs typeface="Arial" pitchFamily="34" charset="0"/>
                </a:rPr>
                <a:t>OsXPB2</a:t>
              </a:r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 Promoter 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715000" y="1981200"/>
              <a:ext cx="838200" cy="43088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Vector backbone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24606" y="1161649"/>
              <a:ext cx="228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694504" y="1164500"/>
              <a:ext cx="228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461082" y="1179481"/>
              <a:ext cx="228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5" name="Rectangle 24"/>
          <p:cNvSpPr/>
          <p:nvPr/>
        </p:nvSpPr>
        <p:spPr>
          <a:xfrm>
            <a:off x="3369276" y="4605976"/>
            <a:ext cx="584062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ry Figure 1.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A) Amplification of 1kb 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sXPB2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romoter from 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. sativ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 (B) Cloning of 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sXPB2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romoter in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JE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2.1 cloning vector and restriction digestion confirmation. (C) Cloning of 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sXPB2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romoter in pCAMBIA191Z and restriction digestion confirmation using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stI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BamHI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enzymes.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1.PPTX</TitleName>
    <StageName xmlns="ad5e6ac6-7e28-44ff-b599-4b096ee3745e" xsi:nil="true"/>
    <DocumentType xmlns="ad5e6ac6-7e28-44ff-b599-4b096ee3745e">Presentation</DocumentType>
    <DocumentId xmlns="ad5e6ac6-7e28-44ff-b599-4b096ee3745e">Presentation 1.PPTX</DocumentId>
  </documentManagement>
</p:properties>
</file>

<file path=customXml/itemProps1.xml><?xml version="1.0" encoding="utf-8"?>
<ds:datastoreItem xmlns:ds="http://schemas.openxmlformats.org/officeDocument/2006/customXml" ds:itemID="{EFB22766-F785-40B2-A690-EC35DD893CCE}"/>
</file>

<file path=customXml/itemProps2.xml><?xml version="1.0" encoding="utf-8"?>
<ds:datastoreItem xmlns:ds="http://schemas.openxmlformats.org/officeDocument/2006/customXml" ds:itemID="{42B04DB1-3B6E-45F4-8A6C-2D2AAC169FB9}"/>
</file>

<file path=customXml/itemProps3.xml><?xml version="1.0" encoding="utf-8"?>
<ds:datastoreItem xmlns:ds="http://schemas.openxmlformats.org/officeDocument/2006/customXml" ds:itemID="{39BC01CB-332B-4F32-B269-3C14A11371F0}"/>
</file>

<file path=docProps/app.xml><?xml version="1.0" encoding="utf-8"?>
<Properties xmlns="http://schemas.openxmlformats.org/officeDocument/2006/extended-properties" xmlns:vt="http://schemas.openxmlformats.org/officeDocument/2006/docPropsVTypes">
  <TotalTime>500</TotalTime>
  <Words>82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ilendra raikwar</dc:creator>
  <cp:lastModifiedBy>A</cp:lastModifiedBy>
  <cp:revision>11</cp:revision>
  <dcterms:created xsi:type="dcterms:W3CDTF">2014-11-26T05:17:22Z</dcterms:created>
  <dcterms:modified xsi:type="dcterms:W3CDTF">2015-04-08T17:33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